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802438" cy="9934575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159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7F7F7F"/>
    <a:srgbClr val="646464"/>
    <a:srgbClr val="8282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084" autoAdjust="0"/>
  </p:normalViewPr>
  <p:slideViewPr>
    <p:cSldViewPr snapToGrid="0" snapToObjects="1">
      <p:cViewPr varScale="1">
        <p:scale>
          <a:sx n="87" d="100"/>
          <a:sy n="87" d="100"/>
        </p:scale>
        <p:origin x="648" y="72"/>
      </p:cViewPr>
      <p:guideLst>
        <p:guide orient="horz" pos="2880"/>
        <p:guide pos="2160"/>
        <p:guide orient="horz" pos="159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47343F-9011-4E48-ACD0-AFDBFF8B6C7E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41425"/>
            <a:ext cx="2513012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F467D0-B869-419D-8DA9-B631581B19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186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873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52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469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4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562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5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60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19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747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419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48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ltGray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645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5900" y="741910"/>
            <a:ext cx="2526402" cy="2274615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793" y="741910"/>
            <a:ext cx="2522134" cy="2274615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2159921" y="123874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671485" y="115294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715293" y="1657983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82469" y="2735290"/>
            <a:ext cx="4509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445570" y="2689124"/>
            <a:ext cx="553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10 U/mL)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980471" y="2689124"/>
            <a:ext cx="527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10 U/mL)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480701" y="2689124"/>
            <a:ext cx="576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10 ng/mL)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97526" y="2735290"/>
            <a:ext cx="812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e-treatment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186261" y="761518"/>
            <a:ext cx="964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□  No stim.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■  TLR7 stim.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510217" y="417105"/>
            <a:ext cx="1129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837 (TLR7)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729455" y="417105"/>
            <a:ext cx="1309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pG2006 (TLR9)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265406" y="761518"/>
            <a:ext cx="9108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□  No stim.</a:t>
            </a:r>
          </a:p>
          <a:p>
            <a:r>
              <a:rPr lang="en-US" altLang="ja-JP" sz="9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TLR9 stim.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90831" y="1064429"/>
            <a:ext cx="338554" cy="13512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%) in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703774" y="1064430"/>
            <a:ext cx="338554" cy="13512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%) in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296086" y="2735290"/>
            <a:ext cx="4509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759187" y="2689124"/>
            <a:ext cx="553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10 U/mL)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294088" y="2689124"/>
            <a:ext cx="527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10 U/mL)</a:t>
            </a: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794318" y="2689124"/>
            <a:ext cx="576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10 ng/mL)</a:t>
            </a: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511143" y="2735290"/>
            <a:ext cx="812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e-treatment</a:t>
            </a:r>
          </a:p>
        </p:txBody>
      </p:sp>
    </p:spTree>
    <p:extLst>
      <p:ext uri="{BB962C8B-B14F-4D97-AF65-F5344CB8AC3E}">
        <p14:creationId xmlns:p14="http://schemas.microsoft.com/office/powerpoint/2010/main" val="20987453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62</TotalTime>
  <Words>92</Words>
  <Application>Microsoft Office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ホワイト</vt:lpstr>
      <vt:lpstr>PowerPoint プレゼンテーション</vt:lpstr>
    </vt:vector>
  </TitlesOfParts>
  <Company>UOE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WATA SHIGERU</dc:creator>
  <cp:lastModifiedBy>圭 阪田</cp:lastModifiedBy>
  <cp:revision>283</cp:revision>
  <cp:lastPrinted>2017-04-10T01:20:45Z</cp:lastPrinted>
  <dcterms:created xsi:type="dcterms:W3CDTF">2016-08-30T03:40:23Z</dcterms:created>
  <dcterms:modified xsi:type="dcterms:W3CDTF">2018-07-25T02:22:58Z</dcterms:modified>
</cp:coreProperties>
</file>